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8" r:id="rId2"/>
    <p:sldId id="265" r:id="rId3"/>
    <p:sldId id="266" r:id="rId4"/>
    <p:sldId id="267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00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12" autoAdjust="0"/>
    <p:restoredTop sz="94660"/>
  </p:normalViewPr>
  <p:slideViewPr>
    <p:cSldViewPr snapToGrid="0">
      <p:cViewPr varScale="1">
        <p:scale>
          <a:sx n="73" d="100"/>
          <a:sy n="73" d="100"/>
        </p:scale>
        <p:origin x="2796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ADIO ANDRES VELASCO SAMPEDRO" userId="4fe01f26-2daf-4667-9ff9-7ff51236cc21" providerId="ADAL" clId="{40A55B68-76B9-43F5-9E75-1BFCD9636A56}"/>
    <pc:docChg chg="custSel modSld">
      <pc:chgData name="ELADIO ANDRES VELASCO SAMPEDRO" userId="4fe01f26-2daf-4667-9ff9-7ff51236cc21" providerId="ADAL" clId="{40A55B68-76B9-43F5-9E75-1BFCD9636A56}" dt="2025-11-04T07:45:13.613" v="63" actId="14100"/>
      <pc:docMkLst>
        <pc:docMk/>
      </pc:docMkLst>
      <pc:sldChg chg="addSp modSp">
        <pc:chgData name="ELADIO ANDRES VELASCO SAMPEDRO" userId="4fe01f26-2daf-4667-9ff9-7ff51236cc21" providerId="ADAL" clId="{40A55B68-76B9-43F5-9E75-1BFCD9636A56}" dt="2025-11-04T07:44:54.206" v="59" actId="2711"/>
        <pc:sldMkLst>
          <pc:docMk/>
          <pc:sldMk cId="2471961744" sldId="265"/>
        </pc:sldMkLst>
        <pc:spChg chg="add mod">
          <ac:chgData name="ELADIO ANDRES VELASCO SAMPEDRO" userId="4fe01f26-2daf-4667-9ff9-7ff51236cc21" providerId="ADAL" clId="{40A55B68-76B9-43F5-9E75-1BFCD9636A56}" dt="2025-11-04T07:42:49.830" v="56" actId="20577"/>
          <ac:spMkLst>
            <pc:docMk/>
            <pc:sldMk cId="2471961744" sldId="265"/>
            <ac:spMk id="9" creationId="{9940C79A-B2DD-4172-84FF-BE1A812871B3}"/>
          </ac:spMkLst>
        </pc:spChg>
        <pc:spChg chg="mod">
          <ac:chgData name="ELADIO ANDRES VELASCO SAMPEDRO" userId="4fe01f26-2daf-4667-9ff9-7ff51236cc21" providerId="ADAL" clId="{40A55B68-76B9-43F5-9E75-1BFCD9636A56}" dt="2025-11-04T07:44:54.206" v="59" actId="2711"/>
          <ac:spMkLst>
            <pc:docMk/>
            <pc:sldMk cId="2471961744" sldId="265"/>
            <ac:spMk id="14" creationId="{0548C43F-5B4D-49B8-A5A7-8136769635D0}"/>
          </ac:spMkLst>
        </pc:spChg>
      </pc:sldChg>
      <pc:sldChg chg="addSp modSp">
        <pc:chgData name="ELADIO ANDRES VELASCO SAMPEDRO" userId="4fe01f26-2daf-4667-9ff9-7ff51236cc21" providerId="ADAL" clId="{40A55B68-76B9-43F5-9E75-1BFCD9636A56}" dt="2025-11-04T07:45:00.994" v="61" actId="2711"/>
        <pc:sldMkLst>
          <pc:docMk/>
          <pc:sldMk cId="1620294899" sldId="266"/>
        </pc:sldMkLst>
        <pc:spChg chg="mod">
          <ac:chgData name="ELADIO ANDRES VELASCO SAMPEDRO" userId="4fe01f26-2daf-4667-9ff9-7ff51236cc21" providerId="ADAL" clId="{40A55B68-76B9-43F5-9E75-1BFCD9636A56}" dt="2025-11-04T07:45:00.994" v="61" actId="2711"/>
          <ac:spMkLst>
            <pc:docMk/>
            <pc:sldMk cId="1620294899" sldId="266"/>
            <ac:spMk id="2" creationId="{17F20AB6-E181-44A8-927A-4961289200EE}"/>
          </ac:spMkLst>
        </pc:spChg>
        <pc:spChg chg="add mod">
          <ac:chgData name="ELADIO ANDRES VELASCO SAMPEDRO" userId="4fe01f26-2daf-4667-9ff9-7ff51236cc21" providerId="ADAL" clId="{40A55B68-76B9-43F5-9E75-1BFCD9636A56}" dt="2025-11-04T07:42:43.581" v="54" actId="20577"/>
          <ac:spMkLst>
            <pc:docMk/>
            <pc:sldMk cId="1620294899" sldId="266"/>
            <ac:spMk id="10" creationId="{9A8454D2-EA81-4B41-996C-A157494D8C75}"/>
          </ac:spMkLst>
        </pc:spChg>
      </pc:sldChg>
      <pc:sldChg chg="addSp modSp">
        <pc:chgData name="ELADIO ANDRES VELASCO SAMPEDRO" userId="4fe01f26-2daf-4667-9ff9-7ff51236cc21" providerId="ADAL" clId="{40A55B68-76B9-43F5-9E75-1BFCD9636A56}" dt="2025-11-04T07:45:13.613" v="63" actId="14100"/>
        <pc:sldMkLst>
          <pc:docMk/>
          <pc:sldMk cId="1531897507" sldId="267"/>
        </pc:sldMkLst>
        <pc:spChg chg="add mod">
          <ac:chgData name="ELADIO ANDRES VELASCO SAMPEDRO" userId="4fe01f26-2daf-4667-9ff9-7ff51236cc21" providerId="ADAL" clId="{40A55B68-76B9-43F5-9E75-1BFCD9636A56}" dt="2025-11-04T07:42:35.210" v="52" actId="1076"/>
          <ac:spMkLst>
            <pc:docMk/>
            <pc:sldMk cId="1531897507" sldId="267"/>
            <ac:spMk id="2" creationId="{32A7F77E-C21A-4D07-98FB-0187E789060E}"/>
          </ac:spMkLst>
        </pc:spChg>
        <pc:spChg chg="mod">
          <ac:chgData name="ELADIO ANDRES VELASCO SAMPEDRO" userId="4fe01f26-2daf-4667-9ff9-7ff51236cc21" providerId="ADAL" clId="{40A55B68-76B9-43F5-9E75-1BFCD9636A56}" dt="2025-10-29T10:25:55.612" v="3" actId="115"/>
          <ac:spMkLst>
            <pc:docMk/>
            <pc:sldMk cId="1531897507" sldId="267"/>
            <ac:spMk id="3" creationId="{352E3A83-24AE-4C3D-B975-0C81D172A19D}"/>
          </ac:spMkLst>
        </pc:spChg>
        <pc:spChg chg="mod">
          <ac:chgData name="ELADIO ANDRES VELASCO SAMPEDRO" userId="4fe01f26-2daf-4667-9ff9-7ff51236cc21" providerId="ADAL" clId="{40A55B68-76B9-43F5-9E75-1BFCD9636A56}" dt="2025-11-04T07:45:13.613" v="63" actId="14100"/>
          <ac:spMkLst>
            <pc:docMk/>
            <pc:sldMk cId="1531897507" sldId="267"/>
            <ac:spMk id="5" creationId="{6E9EFA59-C62A-400B-A33E-9309A42D3AF6}"/>
          </ac:spMkLst>
        </pc:spChg>
      </pc:sldChg>
      <pc:sldChg chg="modSp">
        <pc:chgData name="ELADIO ANDRES VELASCO SAMPEDRO" userId="4fe01f26-2daf-4667-9ff9-7ff51236cc21" providerId="ADAL" clId="{40A55B68-76B9-43F5-9E75-1BFCD9636A56}" dt="2025-11-04T07:44:47.734" v="58" actId="2711"/>
        <pc:sldMkLst>
          <pc:docMk/>
          <pc:sldMk cId="714097663" sldId="268"/>
        </pc:sldMkLst>
        <pc:spChg chg="mod">
          <ac:chgData name="ELADIO ANDRES VELASCO SAMPEDRO" userId="4fe01f26-2daf-4667-9ff9-7ff51236cc21" providerId="ADAL" clId="{40A55B68-76B9-43F5-9E75-1BFCD9636A56}" dt="2025-11-04T07:44:47.734" v="58" actId="2711"/>
          <ac:spMkLst>
            <pc:docMk/>
            <pc:sldMk cId="714097663" sldId="268"/>
            <ac:spMk id="2" creationId="{48137DF7-1912-454E-B336-081B80A2D6F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6843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854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7240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9734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3451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1234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512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06401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3898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114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3916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B25EC-3591-47B7-A979-3FEFA6BE234C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FF9546-536E-4B3C-BCEC-36093433F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8667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48137DF7-1912-454E-B336-081B80A2D6F6}"/>
              </a:ext>
            </a:extLst>
          </p:cNvPr>
          <p:cNvSpPr txBox="1"/>
          <p:nvPr/>
        </p:nvSpPr>
        <p:spPr>
          <a:xfrm>
            <a:off x="633984" y="2648481"/>
            <a:ext cx="5590032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 err="1">
                <a:latin typeface="Palatino Linotype" panose="02040502050505030304" pitchFamily="18" charset="0"/>
              </a:rPr>
              <a:t>Supplementary</a:t>
            </a:r>
            <a:r>
              <a:rPr lang="es-ES" sz="1100" b="1" dirty="0">
                <a:latin typeface="Palatino Linotype" panose="02040502050505030304" pitchFamily="18" charset="0"/>
              </a:rPr>
              <a:t> Figure S3. </a:t>
            </a:r>
            <a:r>
              <a:rPr lang="es-ES" sz="1100" b="1" dirty="0" err="1">
                <a:latin typeface="Palatino Linotype" panose="02040502050505030304" pitchFamily="18" charset="0"/>
              </a:rPr>
              <a:t>Insert</a:t>
            </a:r>
            <a:r>
              <a:rPr lang="es-ES" sz="1100" b="1" dirty="0">
                <a:latin typeface="Palatino Linotype" panose="02040502050505030304" pitchFamily="18" charset="0"/>
              </a:rPr>
              <a:t> </a:t>
            </a:r>
            <a:r>
              <a:rPr lang="es-ES" sz="1100" b="1" dirty="0" err="1">
                <a:latin typeface="Palatino Linotype" panose="02040502050505030304" pitchFamily="18" charset="0"/>
              </a:rPr>
              <a:t>sequences</a:t>
            </a:r>
            <a:r>
              <a:rPr lang="es-ES" sz="1100" b="1" dirty="0">
                <a:latin typeface="Palatino Linotype" panose="02040502050505030304" pitchFamily="18" charset="0"/>
              </a:rPr>
              <a:t> </a:t>
            </a:r>
            <a:r>
              <a:rPr lang="es-ES" sz="1100" b="1" dirty="0" err="1">
                <a:latin typeface="Palatino Linotype" panose="02040502050505030304" pitchFamily="18" charset="0"/>
              </a:rPr>
              <a:t>of</a:t>
            </a:r>
            <a:r>
              <a:rPr lang="es-ES" sz="1100" b="1" dirty="0">
                <a:latin typeface="Palatino Linotype" panose="02040502050505030304" pitchFamily="18" charset="0"/>
              </a:rPr>
              <a:t> </a:t>
            </a:r>
            <a:r>
              <a:rPr lang="es-ES" sz="1100" b="1" dirty="0" err="1">
                <a:latin typeface="Palatino Linotype" panose="02040502050505030304" pitchFamily="18" charset="0"/>
              </a:rPr>
              <a:t>minigenes</a:t>
            </a:r>
            <a:r>
              <a:rPr lang="es-ES" sz="1100" b="1" dirty="0">
                <a:latin typeface="Palatino Linotype" panose="02040502050505030304" pitchFamily="18" charset="0"/>
              </a:rPr>
              <a:t> mgATM_19-22, mgATM_41-44 and mgATM_55-63. </a:t>
            </a: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Exons are indicated in upper case and green font, and cloning sites are underlined. The structure</a:t>
            </a:r>
            <a:r>
              <a:rPr kumimoji="0" lang="en-GB" sz="1100" b="0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 of each insert is indicated below each sequence, where a double slash indicates a shortened intron.</a:t>
            </a:r>
          </a:p>
          <a:p>
            <a:pPr algn="just"/>
            <a:endParaRPr lang="en-GB" sz="1100" dirty="0">
              <a:solidFill>
                <a:prstClr val="black"/>
              </a:solidFill>
              <a:latin typeface="Palatino Linotype" panose="02040502050505030304" pitchFamily="18" charset="0"/>
            </a:endParaRPr>
          </a:p>
          <a:p>
            <a:pPr algn="just"/>
            <a:r>
              <a:rPr lang="en-GB" sz="1100" b="1" dirty="0">
                <a:solidFill>
                  <a:prstClr val="black"/>
                </a:solidFill>
                <a:latin typeface="Palatino Linotype" panose="02040502050505030304" pitchFamily="18" charset="0"/>
              </a:rPr>
              <a:t>S3-(a). </a:t>
            </a:r>
            <a:r>
              <a:rPr lang="en-GB" sz="1100" dirty="0">
                <a:solidFill>
                  <a:prstClr val="black"/>
                </a:solidFill>
                <a:latin typeface="Palatino Linotype" panose="02040502050505030304" pitchFamily="18" charset="0"/>
              </a:rPr>
              <a:t>Insert sequence of minigene mgATM_19-22. </a:t>
            </a:r>
          </a:p>
          <a:p>
            <a:pPr algn="just"/>
            <a:r>
              <a:rPr lang="en-GB" sz="1100" b="1" dirty="0">
                <a:solidFill>
                  <a:prstClr val="black"/>
                </a:solidFill>
                <a:latin typeface="Palatino Linotype" panose="02040502050505030304" pitchFamily="18" charset="0"/>
              </a:rPr>
              <a:t>S3-(b).</a:t>
            </a:r>
            <a:r>
              <a:rPr lang="en-GB" sz="1100" dirty="0">
                <a:solidFill>
                  <a:prstClr val="black"/>
                </a:solidFill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ert</a:t>
            </a:r>
            <a:r>
              <a:rPr lang="es-E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</a:t>
            </a:r>
            <a:r>
              <a:rPr lang="es-E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es-E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nigene</a:t>
            </a:r>
            <a:r>
              <a:rPr lang="es-E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gATM_41-44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-(c).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ert</a:t>
            </a:r>
            <a:r>
              <a:rPr lang="es-E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</a:t>
            </a:r>
            <a:r>
              <a:rPr lang="es-E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es-E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nigene</a:t>
            </a:r>
            <a:r>
              <a:rPr lang="es-E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gATM_</a:t>
            </a:r>
            <a:r>
              <a:rPr lang="es-E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5-63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s-E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40976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659806" y="344758"/>
            <a:ext cx="5787025" cy="3647152"/>
            <a:chOff x="429039" y="356977"/>
            <a:chExt cx="6269276" cy="3951081"/>
          </a:xfrm>
        </p:grpSpPr>
        <p:sp>
          <p:nvSpPr>
            <p:cNvPr id="4" name="Rectangle 3"/>
            <p:cNvSpPr/>
            <p:nvPr/>
          </p:nvSpPr>
          <p:spPr>
            <a:xfrm>
              <a:off x="429039" y="356977"/>
              <a:ext cx="5786232" cy="39510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s-ES" sz="1100" b="1" dirty="0" err="1">
                  <a:solidFill>
                    <a:srgbClr val="C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:</a:t>
              </a:r>
              <a:r>
                <a:rPr lang="es-ES" sz="1100" b="1" i="1" dirty="0" err="1">
                  <a:solidFill>
                    <a:srgbClr val="C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ag</a:t>
              </a:r>
              <a:r>
                <a:rPr lang="es-ES" sz="1100" b="1" dirty="0" err="1">
                  <a:solidFill>
                    <a:srgbClr val="C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endParaRPr lang="es-ES" sz="1100" b="1" u="heavy" dirty="0">
                <a:solidFill>
                  <a:srgbClr val="C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just"/>
              <a:r>
                <a:rPr lang="es-ES" sz="1100" b="1" u="sng" dirty="0">
                  <a:solidFill>
                    <a:srgbClr val="C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GGCCG</a:t>
              </a:r>
              <a:r>
                <a:rPr lang="es-ES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tttgtgtttttagtagagatggagtttcaccatattggccaggctgttctcaaactcctgaccttgtgatctgcctgcttcagcctcccaaagtgctgggattacaggtgtgagccactgcacccggcctatgtttatatactttttaaagtaaatgatttgtggataaacctgatttttttccctcctaccatcttag</a:t>
              </a:r>
              <a:r>
                <a:rPr lang="es-ES" sz="1100" b="1" dirty="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ATCTAATGCTTTTAAAGGAGCTTCCTGGAGAAGAGTACCCCTTGCCAATGGAAGATGTTCTTGAACTTCTGAAACCACTATC</a:t>
              </a:r>
              <a:r>
                <a:rPr lang="es-ES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taagaaattaaaaccttatgttatgttcactttaaagttataaaataactgatgtgttctgttaagcttataaagttgaactttttttttttttttaccacag</a:t>
              </a:r>
              <a:r>
                <a:rPr lang="es-ES" sz="1100" b="1" dirty="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TGTGTGTTCTTTGTATCGTCGTGACCAAGATGTTTGTAAAACTATTTTAAACCATGTCCTTCATGTAGTGAAAAACCTAGGTCAAAGCAATATGGACTCTGAGAACACAAGGGATGCTCAAGGACAGTTTCTTACAGTAATTGGAGCATTTTG</a:t>
              </a:r>
              <a:r>
                <a:rPr lang="es-ES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taggtacagtctattttgtggtcctatttttcttttgctatctgtggatacgaatgcaagttttgtatccacatcagtgatttcttctgatcttcctacatagctaatacatcttttaagaatagcagaatgtaatttgtgtttccctcagtcgcttgaagaactacattgctttttgtttaaggcttggctttctaaagctaaaatgaattcttttacactaatttcttttagcttgaatttttggcaaggtgagtatgttggcatattccacataatgacaaataagtttagcacagaaagacatattggaagtaacttacaataacctttcagtgagttttctgagtgcttttatcagaatgattatttaactttggaaaacttacttgatttcag</a:t>
              </a:r>
              <a:r>
                <a:rPr lang="es-ES" sz="1100" b="1" dirty="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CATCTAACAAAGGAGAGGAAATATATATTCTCTGTAAGAATGGCCCTAGTAAATTGCCTTAAAACTTTGCTTGAG</a:t>
              </a:r>
              <a:r>
                <a:rPr lang="es-ES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tgagtttttgcatttttttagtaagatctccattgaaaattttaaagcagtctttgtttgttaatgagtaatttttctctatttcatatttaaccacagttcttttcccgtag</a:t>
              </a:r>
              <a:r>
                <a:rPr lang="es-ES" sz="1100" b="1" dirty="0">
                  <a:solidFill>
                    <a:schemeClr val="accent6">
                      <a:lumMod val="75000"/>
                    </a:schemeClr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CTGATCCTTATTCAAAATGGGCCATTCTTAATGTAATGGGAAAAGACTTTCCTGTAAATGAAGTATTTACACAATTTCTTGCTGACAATCATCACCAAGTTCGCATGTTGGCTGCAGAGTCAATCAATAG</a:t>
              </a:r>
              <a:r>
                <a:rPr lang="es-ES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taatgggtcaaatattcatgaagtatttggaatgctgcagatggcagtagaatgtcttacatagtaacagctcacagttgcaatattaaaaatagctaacacttgttgagtatatacggtgtgcctggcatttatgtttattcttaattcttatacttctgtcacttagattctattatttccttcaatttataaatga</a:t>
              </a:r>
              <a:r>
                <a:rPr lang="es-ES" sz="1100" b="1" u="sng" dirty="0">
                  <a:solidFill>
                    <a:srgbClr val="C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GATCC</a:t>
              </a:r>
            </a:p>
            <a:p>
              <a:pPr algn="just"/>
              <a:r>
                <a:rPr lang="es-ES" sz="1100" b="1" dirty="0">
                  <a:solidFill>
                    <a:srgbClr val="538135"/>
                  </a:solidFill>
                  <a:latin typeface="Calibri" panose="020F0502020204030204" pitchFamily="34" charset="0"/>
                  <a:cs typeface="Times New Roman" panose="02020603050405020304" pitchFamily="18" charset="0"/>
                </a:rPr>
                <a:t>                                             </a:t>
              </a:r>
              <a:r>
                <a:rPr lang="es-ES" sz="1100" b="1" dirty="0" err="1">
                  <a:solidFill>
                    <a:srgbClr val="C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:</a:t>
              </a:r>
              <a:r>
                <a:rPr lang="es-ES" sz="1100" b="1" i="1" dirty="0" err="1">
                  <a:solidFill>
                    <a:srgbClr val="C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am</a:t>
              </a:r>
              <a:r>
                <a:rPr lang="es-ES" sz="1100" b="1" dirty="0" err="1">
                  <a:solidFill>
                    <a:srgbClr val="C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I</a:t>
              </a:r>
              <a:endParaRPr lang="en-GB" sz="1100" dirty="0">
                <a:solidFill>
                  <a:srgbClr val="C00000"/>
                </a:solidFill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116211" y="905383"/>
              <a:ext cx="582104" cy="3334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Ex19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116211" y="1414644"/>
              <a:ext cx="582104" cy="3334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Ex20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116210" y="2616494"/>
              <a:ext cx="582104" cy="3334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Ex21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116210" y="3159292"/>
              <a:ext cx="582104" cy="3334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Ex22</a:t>
              </a:r>
            </a:p>
          </p:txBody>
        </p:sp>
      </p:grpSp>
      <p:sp>
        <p:nvSpPr>
          <p:cNvPr id="14" name="TextBox 16">
            <a:extLst>
              <a:ext uri="{FF2B5EF4-FFF2-40B4-BE49-F238E27FC236}">
                <a16:creationId xmlns:a16="http://schemas.microsoft.com/office/drawing/2014/main" id="{0548C43F-5B4D-49B8-A5A7-8136769635D0}"/>
              </a:ext>
            </a:extLst>
          </p:cNvPr>
          <p:cNvSpPr txBox="1"/>
          <p:nvPr/>
        </p:nvSpPr>
        <p:spPr>
          <a:xfrm>
            <a:off x="633984" y="4052865"/>
            <a:ext cx="5590032" cy="970478"/>
          </a:xfrm>
          <a:prstGeom prst="round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Palatino Linotype" panose="02040502050505030304" pitchFamily="18" charset="0"/>
              </a:rPr>
              <a:t>Figure S3-(a)</a:t>
            </a:r>
            <a:r>
              <a:rPr lang="es-E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ert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nigene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gATM_19-22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ize of the insert: 1476bp. Structure: ivs18 (200bp) – ex19 (83bp) – ivs19 (104bp) – ivs20 (200bp) // ivs20 (200bp) – ex21 (76bp) – ivs21 (114bp) –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22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31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) – ivs22 (200bp).</a:t>
            </a:r>
            <a:endParaRPr lang="es-E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GB" sz="1100" dirty="0">
              <a:latin typeface="Palatino Linotype" panose="0204050205050503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940C79A-B2DD-4172-84FF-BE1A812871B3}"/>
              </a:ext>
            </a:extLst>
          </p:cNvPr>
          <p:cNvSpPr txBox="1"/>
          <p:nvPr/>
        </p:nvSpPr>
        <p:spPr>
          <a:xfrm>
            <a:off x="310821" y="285259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Palatino Linotype" panose="02040502050505030304" pitchFamily="18" charset="0"/>
              </a:rPr>
              <a:t>(a)</a:t>
            </a:r>
          </a:p>
        </p:txBody>
      </p:sp>
    </p:spTree>
    <p:extLst>
      <p:ext uri="{BB962C8B-B14F-4D97-AF65-F5344CB8AC3E}">
        <p14:creationId xmlns:p14="http://schemas.microsoft.com/office/powerpoint/2010/main" val="24719617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6">
            <a:extLst>
              <a:ext uri="{FF2B5EF4-FFF2-40B4-BE49-F238E27FC236}">
                <a16:creationId xmlns:a16="http://schemas.microsoft.com/office/drawing/2014/main" id="{17F20AB6-E181-44A8-927A-4961289200EE}"/>
              </a:ext>
            </a:extLst>
          </p:cNvPr>
          <p:cNvSpPr txBox="1"/>
          <p:nvPr/>
        </p:nvSpPr>
        <p:spPr>
          <a:xfrm>
            <a:off x="633984" y="3994700"/>
            <a:ext cx="5590032" cy="1157764"/>
          </a:xfrm>
          <a:prstGeom prst="round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Palatino Linotype" panose="02040502050505030304" pitchFamily="18" charset="0"/>
              </a:rPr>
              <a:t>Figure S3-(b)</a:t>
            </a:r>
            <a:r>
              <a:rPr lang="es-E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ert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nigene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gATM_41-44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ize of the insert: 1543bp. Structure: ivs40 (170bp) – ex41 (89bp) – ivs41 (99bp) – ex42 (103bp) – ivs42 (200bp) // ivs42 (135bp) – ex43 (149bp) – ivs43 (94bp) // ivs43 (199bp) – ex44 (105bp) – ivs44 (200bp).</a:t>
            </a:r>
            <a:endParaRPr lang="es-E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GB" sz="1100" dirty="0">
              <a:latin typeface="Palatino Linotype" panose="02040502050505030304" pitchFamily="18" charset="0"/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0A2F847D-6D32-4D3E-9C18-DD16573EDE41}"/>
              </a:ext>
            </a:extLst>
          </p:cNvPr>
          <p:cNvSpPr txBox="1"/>
          <p:nvPr/>
        </p:nvSpPr>
        <p:spPr>
          <a:xfrm>
            <a:off x="633984" y="516825"/>
            <a:ext cx="5366960" cy="3477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ccggtgaactgtatttcagaactgtatttcagaatcattacattttatttctataacataacatttagagttgggagttacatattggtaatgatacaatttaaaatttgctaaatttatagaccgattttttttccttcttcaatttttgttgtttccatgttttcag</a:t>
            </a:r>
            <a:r>
              <a:rPr lang="es-ES" sz="1100" b="1" dirty="0">
                <a:solidFill>
                  <a:srgbClr val="538135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TCTTCTCTTAGAAATCTACAGAAGTATAGGGGAGCCAGATAGTTTGTATGGCTGTGGTGGAGGGAAGATGTTACAACCCATTACTAG</a:t>
            </a:r>
            <a:r>
              <a:rPr lang="es-E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aaattgcatttttctaaacaacggtatagtaattctgtttatgaaggagttatgtgtgtgtaaaacccaaagctattttcacaatcttttcttatag</a:t>
            </a:r>
            <a:r>
              <a:rPr lang="es-ES" sz="1100" b="1" dirty="0">
                <a:solidFill>
                  <a:srgbClr val="538135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TACGAACATATGAACACGAAGCAATGTGGGGCAAAGCCCTAGTAACATATGACCTCGAAACAGCAATCCCCTCATCAACACGCCAGGCAGGAATCATTCAG</a:t>
            </a:r>
            <a:r>
              <a:rPr lang="es-E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acattttttcccagatttggtaaagccatcactagtgtagtgctgaggttatttcagtatgttggtggatatttacacagccagataaactctagagataagactagaacttatctgtttttcagaggattaggctaaacattcagggatactcctgaagcagagggatgcaaaaaaaagagaaaaaattcagggagatgatattttgggattttaaatgatattgtgaactaaaatttgtctaagttaatttgtatctttgctgtttttttctctggttttctgttgatatctttgattacttaacttaaaaacaaaataactcctgtttag</a:t>
            </a:r>
            <a:r>
              <a:rPr lang="es-ES" sz="1100" b="1" dirty="0">
                <a:solidFill>
                  <a:srgbClr val="538135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CCTTGCAGAATTTGGGACTCTGCCATATTCTTTCCGTCTATTTAAAAGGATTGGATTATGAAAATAAAGACTGGTGTCCTGAACTAGAAGAACTTCATTACCAAGCAGCATGGAGGAATATGCAGTGGGACCATTGCACTTCCGTCAG</a:t>
            </a:r>
            <a:r>
              <a:rPr lang="es-E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aagaaatttgacttgatttttttttttttgcctctctcctcattctaaacaacaactgtttttctcttctatgaatataacaggagttgttttgagtaatttcctttttttctgcttaaagaatttaaatgactcataaaatttgtatttcttaccaaaaattctagaaatgcattttttagaatggagaaatgttaatttaaaaattttgtcctttggtgaagctatttatacatgtatatcttagggttctgtttttaagtatatttttttctttgacttatctcacag</a:t>
            </a:r>
            <a:r>
              <a:rPr lang="es-ES" sz="1100" b="1" dirty="0">
                <a:solidFill>
                  <a:srgbClr val="538135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AAGAAGTAGAAGGAACCAGTTACCATGAATCATTGTACAATGCTCTACAATCTCTAAGAGACAGAGAATTCTCTACATTTTATGAAAGTCTCAAATATGCCAG</a:t>
            </a:r>
            <a:r>
              <a:rPr lang="es-E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attatgaaaagacaaagttactgtattttaacatttaatgtcatggcttcttttctgaaaacttgagaaacaattttaatgtaaggatttgcattgatgaagagataaagacttggtggctgtgatcagatgtttccttgtaattctctgccctccttcaaaacaaattgtttctgggattccaggttcattctttac</a:t>
            </a:r>
            <a:endParaRPr lang="es-ES" sz="1100" dirty="0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7A1DD60F-71F1-41B4-993E-767A2B34F688}"/>
              </a:ext>
            </a:extLst>
          </p:cNvPr>
          <p:cNvSpPr txBox="1"/>
          <p:nvPr/>
        </p:nvSpPr>
        <p:spPr>
          <a:xfrm>
            <a:off x="6034449" y="808690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41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2F91827A-25C3-4011-8B0B-5B4D44A4096F}"/>
              </a:ext>
            </a:extLst>
          </p:cNvPr>
          <p:cNvSpPr txBox="1"/>
          <p:nvPr/>
        </p:nvSpPr>
        <p:spPr>
          <a:xfrm>
            <a:off x="6034449" y="1255630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42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FCF131BA-F77C-453F-8B15-E4CB310BB407}"/>
              </a:ext>
            </a:extLst>
          </p:cNvPr>
          <p:cNvSpPr txBox="1"/>
          <p:nvPr/>
        </p:nvSpPr>
        <p:spPr>
          <a:xfrm>
            <a:off x="6034449" y="2155677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43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9B72E136-72FB-4288-82F4-3FAAD5FDDDB3}"/>
              </a:ext>
            </a:extLst>
          </p:cNvPr>
          <p:cNvSpPr txBox="1"/>
          <p:nvPr/>
        </p:nvSpPr>
        <p:spPr>
          <a:xfrm>
            <a:off x="6034449" y="3058731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4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A8454D2-EA81-4B41-996C-A157494D8C75}"/>
              </a:ext>
            </a:extLst>
          </p:cNvPr>
          <p:cNvSpPr txBox="1"/>
          <p:nvPr/>
        </p:nvSpPr>
        <p:spPr>
          <a:xfrm>
            <a:off x="310821" y="285259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Palatino Linotype" panose="0204050205050503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16202948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352E3A83-24AE-4C3D-B975-0C81D172A19D}"/>
              </a:ext>
            </a:extLst>
          </p:cNvPr>
          <p:cNvSpPr txBox="1"/>
          <p:nvPr/>
        </p:nvSpPr>
        <p:spPr>
          <a:xfrm>
            <a:off x="633984" y="280416"/>
            <a:ext cx="5721476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000" b="1" dirty="0" err="1">
                <a:solidFill>
                  <a:srgbClr val="C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:</a:t>
            </a:r>
            <a:r>
              <a:rPr lang="es-ES" sz="1000" b="1" i="1" dirty="0" err="1">
                <a:solidFill>
                  <a:srgbClr val="C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ag</a:t>
            </a:r>
            <a:r>
              <a:rPr lang="es-ES" sz="1000" b="1" dirty="0" err="1">
                <a:solidFill>
                  <a:srgbClr val="C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endParaRPr lang="es-ES" sz="1000" b="1" dirty="0">
              <a:solidFill>
                <a:srgbClr val="C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s-ES" sz="1000" b="1" u="sng" dirty="0">
                <a:solidFill>
                  <a:srgbClr val="C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GGCCG</a:t>
            </a:r>
            <a:r>
              <a:rPr lang="es-E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tagtgaatctttgatgaaacagtagttaaagttacgagcgtgagccaccacacccggcctaaagttgtagttcttaaccactatcacatcgtcatttgtttctctgtttaatattaaaattgccatttataatgtatttttctttaagtgcaaatagtgtatctgacctattatcaatcatgtttatacttttattag</a:t>
            </a:r>
            <a:r>
              <a:rPr lang="es-ES" sz="1000" b="1" dirty="0">
                <a:solidFill>
                  <a:schemeClr val="accent6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GGACCACACAGGAGAATATGGAAATCTGGTGACTATACAGTCATTTAAAGCAGAATTTCGCTTAGCAGGAGGTGTAAATTTACCAAAAATAATAGATTGTGTAGGTTCCGATGGCAAGGAGAGGAGACAGCTTGTTAAG</a:t>
            </a:r>
            <a:r>
              <a:rPr lang="es-E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gagccttcccttctctggcttagcccttagagttttagtgatgaaaatttttagttcatattttctttctgctttatttgggattttgtctttattttgaatacttacaaatgaggaagatttgtagagtagaaatgcattattttctagaaccaggcttttctccattttttttgtgtctctgaaagacaatcattaaaactttctaaatcagtgtaaatgttgtagcttattctaaatgaaagaatggcagtaggtatttaattatttgggagactgtcaagaggtgcacagatgctcagattggtttgagtgccctttgctattctcagatgactctgtgtttttataataaaataaactgtacttgtttattcatgcttaattattctgaag</a:t>
            </a:r>
            <a:r>
              <a:rPr lang="es-ES" sz="1000" b="1" dirty="0">
                <a:solidFill>
                  <a:schemeClr val="accent6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GCCGTGATGACCTGAGACAAGATGCTGTCATGCAACAGGTCTTCCAGATGTGTAATACATTACTGCAGAGAAACACGGAAACTAGGAAGAGGAAATTAACTATCTGTACTTATAAG</a:t>
            </a:r>
            <a:r>
              <a:rPr lang="es-E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aactatttgtacttctgttagttcaccaaaaacatataaaagatgccatttggttgggtgaagtggctcatgcccatattcataatgctttgggaggccaaggtgggaggattgcttgaggccaggagttcgagaccagcctcagcaacatagtgagaccccatcttgacaaaaagttaaaaaaaaaaaaaaagccagagatgatggcatgtgcttgtagtcccttagctacatgggaggctgaggtgggaggatcacttgagtccaggagtttgaggctgcagtgagctcaaactctgcagtgagccccagtccagcctgagcaacacagcaagatcccgtttaaaaaagaagaagaagaagaacagcaggctggaaaattatattctttgagcttaagtttatttccgattggtttcctccaaggagctttgtcttctatggacagagaaatattaatacaacttgaaaaaaaatgctttgcactgactctgatagctgaatgatcatcaaatgctctttaatggccttttaaaattaaaaggtatttaatctgtaactccag</a:t>
            </a:r>
            <a:r>
              <a:rPr lang="es-ES" sz="1000" b="1" dirty="0">
                <a:solidFill>
                  <a:schemeClr val="accent6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GGTTCCCCTCTCTCAGCGAAGTGGTGTTCTTGAATGGTGCACAGGAACTGTCCCCATTGGTGAATTTCTTGTTAACAATGAAGATGGTGCTCATAAAAGATACAGGCCAAATGATTTCAGTGCCTTTCAGTGCCAAAAGAAAATGATG</a:t>
            </a:r>
            <a:r>
              <a:rPr lang="es-E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gagtgacacccaaaattaaaggttattgtaagattatttaatggcttattaaagctgacagctgtcagatattatagaatacaaaaaaactttaatttcatcaggtaattgtcaaagatactaagtaaaagaaaaactcatcagaatgaaagtgtgtgagtgaaaaaggaaggattttaaactacataatatgtcaaccaacaattaatatggaaatcctaaagggattatcacttgtaattaattgcttccctgtccagactgttagcttcttgtaggtaatgtatcctgttcatctttattgcccctatatctgtcatatttttatataaaaatgtgtatattagtttaattgaacacaatattgaaaaataattatatatattctctatttaaag</a:t>
            </a:r>
            <a:r>
              <a:rPr lang="es-ES" sz="1000" b="1" dirty="0">
                <a:solidFill>
                  <a:schemeClr val="accent6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GGTGCAAAAAAAGTCTTTTGAAGAGAAATATGAAGTCTTCATGGATGTTTGCCAAAATTTTCAACCAGTTTTCCGTTACTTCTGCATGGAAAAATTCTTGGATCCAGCTATTTGGTTTGAGAAGCGATTGGCTTATACGCGCAGTGTAGCTACTTCTTCTATTG</a:t>
            </a:r>
            <a:r>
              <a:rPr lang="es-E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aatcttcttgtacatatagtagattgagcactttgttgtttggcaggttttatttttgtttgattcagcactttttctacattctgagttgcagggggatgatagtgatgatgtggttagtaaccaacccatcttcattattaaatcatatgtttcttgttcatcctgattcttagtgtctacctttttataacttataaaatgcaatatgcattaaaatagctggcaagatttgagttaaactcaacatggccggttatgcacatcatttaagtaggctaaaaatcctaaactacttaaagattataccaagtcagtggtcttaattgaaattatggctatatattagaaagagatggaatcagtgatttcagattgtttgtttcttttttctccag</a:t>
            </a:r>
            <a:r>
              <a:rPr lang="es-ES" sz="1000" b="1" dirty="0">
                <a:solidFill>
                  <a:schemeClr val="accent6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TGGTTACATACTTGGACTTGGTGATAGACATGTACAGAATATCTTGATAAATGAGCAGTCAGCAGAACTTGTACATATAGATCTAG</a:t>
            </a:r>
            <a:r>
              <a:rPr lang="es-E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aagtaataaaatctatgtatctattctttttagtaaatatttggtcatcatggaatgttgtttgcctaccaagatattacaaatataagagacagataaattgaagcagtaaatattgggtttttttgttttcagcataaacagttgtcctagaagaaacagttaactctgcctggggtactgagtgaaacttaataatttggatttgaggtggatctcacagacagtgacaaagatgaggaaggcagccagagcagaagtaaactactgtacatactagtgttcatagaacgtaggtaacatgtggtttcttgcctttgtaaagttcacattctaactggaaagaaagtaaattagctgtcaaacctcctaacttcactgtattctttactttag</a:t>
            </a:r>
            <a:r>
              <a:rPr lang="es-ES" sz="1000" b="1" dirty="0">
                <a:solidFill>
                  <a:schemeClr val="accent6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GTTGCTTTTGAACAGGGCAAAATCCTTCCTACTCCTGAGACAGTTCCTTTTAGACTCACCAGAGATATTGTGGATGGCATGGGCATTACGGGTGTTGAAGGTGTCTTCAGAAG</a:t>
            </a:r>
            <a:r>
              <a:rPr lang="es-E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aagtgatatgaagtaaaggagggaaataatttttgatgtcaaaattacatgggctgggcatggttctttgcacctgtaatcccagctgctcaagaggctgaagtgggaggattgtttgagcccaggagtttgagtccagcctaggcaatacagcaagaccctgtatctaaaaaaaaaatagtcaaatacatatttgtattcatttcaaacgtctaatgaaagcccactctgccaagtattatgctattttgagatacagatatgtagattattaagcataggctcagcatactacacatgagagtatacagataaagatacgttgacaacattggtgtgtaacaaaatccgtatttataatgtgtttgactctag</a:t>
            </a:r>
            <a:r>
              <a:rPr lang="es-ES" sz="1000" b="1" dirty="0">
                <a:solidFill>
                  <a:schemeClr val="accent6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GCTGTGAGAAAACCATGGAAGTGATGAGAAACTCTCAGGAAACTCTGTTAACCATTGTAGAG</a:t>
            </a:r>
            <a:r>
              <a:rPr lang="es-E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aaagtattttataaggaagactttattttttttcttaccaggtagactgtgtatctcatcaggaagtcactgatgtgaagagcactgcttcattttaacatagggggatgtggctgggcagcagaaaggaggagattgtgcacttagccttttcacacatccaaaaatactggtttagaaatgccttcagcccccttgaattcagaatgaaatgagaagcttggagcattatgctaggatagtttcctcaaggaaacatgaagtgtgcatgatgtttgttcccctcccccatcaactaccatgtgactggcttatttgtatgatactggttctactgtttctaagtatgtgattaaaatgtacattgttcttttaatacatatgttctctctgtttag</a:t>
            </a:r>
            <a:r>
              <a:rPr lang="es-ES" sz="1000" b="1" dirty="0">
                <a:solidFill>
                  <a:schemeClr val="accent6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CCTTCTATATGATCCACTCTTTGACTGGACCATGAATCCTTTGAAAGCTTTGTATTTACAGCAGAGGCCGGAAGATGAAACTGAGCTTCACCCTACTCTGAATGCAGATGACCAAGAATGCAAACGAAATCTCAG</a:t>
            </a:r>
            <a:r>
              <a:rPr lang="es-E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tgagcagtattttaagaaggtcctgttgtcagtttttcagattttcttattcccaaggcctttaaactgttcacctcactgaaacctttgtgtttttgtccttag</a:t>
            </a:r>
            <a:r>
              <a:rPr lang="es-ES" sz="1000" b="1" dirty="0">
                <a:solidFill>
                  <a:schemeClr val="accent6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GATATTGACCAGAGTTTCAACAAAGTAGCTGAACGTGTCTTAATGAGACTACAAGAGAAACTGAAAGGAGTGGAAGAAGGCACTGTGCTCAGTGTT - </a:t>
            </a:r>
            <a:r>
              <a:rPr lang="es-ES" sz="1000" b="1" dirty="0">
                <a:ea typeface="Calibri" panose="020F0502020204030204" pitchFamily="34" charset="0"/>
                <a:cs typeface="Times New Roman" panose="02020603050405020304" pitchFamily="18" charset="0"/>
              </a:rPr>
              <a:t>EXON-V2-pSAD</a:t>
            </a:r>
            <a:endParaRPr lang="es-ES" sz="1000" b="1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5" name="TextBox 16">
            <a:extLst>
              <a:ext uri="{FF2B5EF4-FFF2-40B4-BE49-F238E27FC236}">
                <a16:creationId xmlns:a16="http://schemas.microsoft.com/office/drawing/2014/main" id="{6E9EFA59-C62A-400B-A33E-9309A42D3AF6}"/>
              </a:ext>
            </a:extLst>
          </p:cNvPr>
          <p:cNvSpPr txBox="1"/>
          <p:nvPr/>
        </p:nvSpPr>
        <p:spPr>
          <a:xfrm>
            <a:off x="633984" y="7509742"/>
            <a:ext cx="5590032" cy="1345049"/>
          </a:xfrm>
          <a:prstGeom prst="round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Palatino Linotype" panose="02040502050505030304" pitchFamily="18" charset="0"/>
              </a:rPr>
              <a:t>Figure S3-(c)</a:t>
            </a:r>
            <a:r>
              <a:rPr lang="es-E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ert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nigene</a:t>
            </a:r>
            <a:r>
              <a:rPr lang="es-E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gATM_</a:t>
            </a:r>
            <a:r>
              <a:rPr lang="es-ES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5-63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ize of the insert: 4326bp. Structure: ivs54 (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) – ex55 (141bp) – ivs55 (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) // ivs55 (198bp) –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56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117bp) – ivs56 (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67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) // ivs56 (200bp) –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57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150bp)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– ivs57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) // ivs57 (200bp) – ex58  (166bp) – ivs58 (200bp) // ivs58 (200bp) – ex59 (89bp) – ivs59 (199bp) // ivs59 (199bp) –ex60 (115bp) – ivs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0 (177bp) // ivs60 (200bp) – ex61 (64bp) – ivs61 (200bp) // ivs61 (200bp) – ex62 (137bp) – ivs62 (106bp) – ex63 (97bp).  </a:t>
            </a:r>
            <a:endParaRPr lang="en-GB" sz="1100" dirty="0">
              <a:latin typeface="Palatino Linotype" panose="02040502050505030304" pitchFamily="18" charset="0"/>
            </a:endParaRP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8E3984DA-2421-4ABB-BE81-90DAAE611448}"/>
              </a:ext>
            </a:extLst>
          </p:cNvPr>
          <p:cNvSpPr txBox="1"/>
          <p:nvPr/>
        </p:nvSpPr>
        <p:spPr>
          <a:xfrm>
            <a:off x="6224016" y="797539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55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B1732A67-F7E2-4B5C-9480-543CE47C539D}"/>
              </a:ext>
            </a:extLst>
          </p:cNvPr>
          <p:cNvSpPr txBox="1"/>
          <p:nvPr/>
        </p:nvSpPr>
        <p:spPr>
          <a:xfrm>
            <a:off x="6224016" y="5210858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60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51DE2FFD-C7BA-48F5-AAD0-D1DCAD019880}"/>
              </a:ext>
            </a:extLst>
          </p:cNvPr>
          <p:cNvSpPr txBox="1"/>
          <p:nvPr/>
        </p:nvSpPr>
        <p:spPr>
          <a:xfrm>
            <a:off x="6224016" y="5975294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61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88E5AB79-913F-4AB2-A0EA-5B495A2B323A}"/>
              </a:ext>
            </a:extLst>
          </p:cNvPr>
          <p:cNvSpPr txBox="1"/>
          <p:nvPr/>
        </p:nvSpPr>
        <p:spPr>
          <a:xfrm>
            <a:off x="6224016" y="6777693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62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F144D7EB-353E-4854-99BB-737B1B228862}"/>
              </a:ext>
            </a:extLst>
          </p:cNvPr>
          <p:cNvSpPr txBox="1"/>
          <p:nvPr/>
        </p:nvSpPr>
        <p:spPr>
          <a:xfrm>
            <a:off x="6224016" y="7199290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63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C3543E2C-C592-4F3D-9A69-4ACBA2400F4E}"/>
              </a:ext>
            </a:extLst>
          </p:cNvPr>
          <p:cNvSpPr txBox="1"/>
          <p:nvPr/>
        </p:nvSpPr>
        <p:spPr>
          <a:xfrm>
            <a:off x="6224016" y="4438730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59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AB1DA54B-31B1-4858-8FEA-50AF73B6DD36}"/>
              </a:ext>
            </a:extLst>
          </p:cNvPr>
          <p:cNvSpPr txBox="1"/>
          <p:nvPr/>
        </p:nvSpPr>
        <p:spPr>
          <a:xfrm>
            <a:off x="6224016" y="3591552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58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FEA67247-3147-45DB-B6D7-B79A5487CCB2}"/>
              </a:ext>
            </a:extLst>
          </p:cNvPr>
          <p:cNvSpPr txBox="1"/>
          <p:nvPr/>
        </p:nvSpPr>
        <p:spPr>
          <a:xfrm>
            <a:off x="6224016" y="2635116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57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5A95C4B6-DD3A-4E01-8034-CF2688B858BB}"/>
              </a:ext>
            </a:extLst>
          </p:cNvPr>
          <p:cNvSpPr txBox="1"/>
          <p:nvPr/>
        </p:nvSpPr>
        <p:spPr>
          <a:xfrm>
            <a:off x="6224016" y="1577130"/>
            <a:ext cx="512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Ex56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A7F77E-C21A-4D07-98FB-0187E789060E}"/>
              </a:ext>
            </a:extLst>
          </p:cNvPr>
          <p:cNvSpPr txBox="1"/>
          <p:nvPr/>
        </p:nvSpPr>
        <p:spPr>
          <a:xfrm>
            <a:off x="310821" y="28525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Palatino Linotype" panose="02040502050505030304" pitchFamily="18" charset="0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1531897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41</TotalTime>
  <Words>424</Words>
  <Application>Microsoft Office PowerPoint</Application>
  <PresentationFormat>A4 (210 x 297 mm)</PresentationFormat>
  <Paragraphs>34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Theme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 Bueno Martinez</dc:creator>
  <cp:lastModifiedBy>LARA SANOGUERA MIRALLES</cp:lastModifiedBy>
  <cp:revision>191</cp:revision>
  <dcterms:created xsi:type="dcterms:W3CDTF">2020-03-02T12:12:44Z</dcterms:created>
  <dcterms:modified xsi:type="dcterms:W3CDTF">2025-11-04T13:23:29Z</dcterms:modified>
</cp:coreProperties>
</file>